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9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0822A-05CB-455E-87EB-DAF5EF353491}" type="datetimeFigureOut">
              <a:rPr lang="ko-KR" altLang="en-US" smtClean="0"/>
              <a:t>2017-02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22298-54F5-467D-8932-C4C89638F9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13066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0822A-05CB-455E-87EB-DAF5EF353491}" type="datetimeFigureOut">
              <a:rPr lang="ko-KR" altLang="en-US" smtClean="0"/>
              <a:t>2017-02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22298-54F5-467D-8932-C4C89638F9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3310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0822A-05CB-455E-87EB-DAF5EF353491}" type="datetimeFigureOut">
              <a:rPr lang="ko-KR" altLang="en-US" smtClean="0"/>
              <a:t>2017-02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22298-54F5-467D-8932-C4C89638F9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3730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0822A-05CB-455E-87EB-DAF5EF353491}" type="datetimeFigureOut">
              <a:rPr lang="ko-KR" altLang="en-US" smtClean="0"/>
              <a:t>2017-02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22298-54F5-467D-8932-C4C89638F9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4679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0822A-05CB-455E-87EB-DAF5EF353491}" type="datetimeFigureOut">
              <a:rPr lang="ko-KR" altLang="en-US" smtClean="0"/>
              <a:t>2017-02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22298-54F5-467D-8932-C4C89638F9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1070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0822A-05CB-455E-87EB-DAF5EF353491}" type="datetimeFigureOut">
              <a:rPr lang="ko-KR" altLang="en-US" smtClean="0"/>
              <a:t>2017-02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22298-54F5-467D-8932-C4C89638F9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26612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0822A-05CB-455E-87EB-DAF5EF353491}" type="datetimeFigureOut">
              <a:rPr lang="ko-KR" altLang="en-US" smtClean="0"/>
              <a:t>2017-02-13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22298-54F5-467D-8932-C4C89638F9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25342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0822A-05CB-455E-87EB-DAF5EF353491}" type="datetimeFigureOut">
              <a:rPr lang="ko-KR" altLang="en-US" smtClean="0"/>
              <a:t>2017-02-1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22298-54F5-467D-8932-C4C89638F9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9426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0822A-05CB-455E-87EB-DAF5EF353491}" type="datetimeFigureOut">
              <a:rPr lang="ko-KR" altLang="en-US" smtClean="0"/>
              <a:t>2017-02-13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22298-54F5-467D-8932-C4C89638F9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50086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0822A-05CB-455E-87EB-DAF5EF353491}" type="datetimeFigureOut">
              <a:rPr lang="ko-KR" altLang="en-US" smtClean="0"/>
              <a:t>2017-02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22298-54F5-467D-8932-C4C89638F9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86732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0822A-05CB-455E-87EB-DAF5EF353491}" type="datetimeFigureOut">
              <a:rPr lang="ko-KR" altLang="en-US" smtClean="0"/>
              <a:t>2017-02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22298-54F5-467D-8932-C4C89638F9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50789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10822A-05CB-455E-87EB-DAF5EF353491}" type="datetimeFigureOut">
              <a:rPr lang="ko-KR" altLang="en-US" smtClean="0"/>
              <a:t>2017-02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822298-54F5-467D-8932-C4C89638F9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24622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표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8124550"/>
              </p:ext>
            </p:extLst>
          </p:nvPr>
        </p:nvGraphicFramePr>
        <p:xfrm>
          <a:off x="1259632" y="292886"/>
          <a:ext cx="2495548" cy="3785616"/>
        </p:xfrm>
        <a:graphic>
          <a:graphicData uri="http://schemas.openxmlformats.org/drawingml/2006/table">
            <a:tbl>
              <a:tblPr firstRow="1" firstCol="1" bandRow="1"/>
              <a:tblGrid>
                <a:gridCol w="427320"/>
                <a:gridCol w="448844"/>
                <a:gridCol w="448844"/>
                <a:gridCol w="448844"/>
                <a:gridCol w="360848"/>
                <a:gridCol w="360848"/>
              </a:tblGrid>
              <a:tr h="252730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 dirty="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CIN3 </a:t>
                      </a:r>
                      <a:endParaRPr lang="ko-KR" sz="10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 dirty="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case </a:t>
                      </a:r>
                      <a:endParaRPr lang="ko-KR" sz="10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CK7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CK19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p16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HPV ISH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7175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7175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2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175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3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175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4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175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5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175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6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C9CF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175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7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C9CF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175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8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508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9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175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0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175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1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175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2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B5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 dirty="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636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3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175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4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636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5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652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6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636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7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175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8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175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9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636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20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636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21</a:t>
                      </a:r>
                      <a:endParaRPr lang="ko-KR" sz="10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636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22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652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23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250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24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652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25</a:t>
                      </a:r>
                      <a:endParaRPr lang="ko-KR" sz="10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 dirty="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10" name="표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23941779"/>
              </p:ext>
            </p:extLst>
          </p:nvPr>
        </p:nvGraphicFramePr>
        <p:xfrm>
          <a:off x="5940152" y="302030"/>
          <a:ext cx="2155846" cy="4529085"/>
        </p:xfrm>
        <a:graphic>
          <a:graphicData uri="http://schemas.openxmlformats.org/drawingml/2006/table">
            <a:tbl>
              <a:tblPr firstRow="1" firstCol="1" bandRow="1"/>
              <a:tblGrid>
                <a:gridCol w="369152"/>
                <a:gridCol w="387746"/>
                <a:gridCol w="387746"/>
                <a:gridCol w="387746"/>
                <a:gridCol w="311728"/>
                <a:gridCol w="311728"/>
              </a:tblGrid>
              <a:tr h="24224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 dirty="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SCC</a:t>
                      </a:r>
                      <a:endParaRPr lang="ko-KR" sz="9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 dirty="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case</a:t>
                      </a:r>
                      <a:endParaRPr lang="ko-KR" sz="9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CK7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CK19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p16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HPV ISH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0854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2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 dirty="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 dirty="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3</a:t>
                      </a:r>
                      <a:endParaRPr lang="ko-KR" sz="9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4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5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0854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6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7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8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9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0854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0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1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2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B5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 dirty="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3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0854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4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B5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5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6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7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0854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8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19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 dirty="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20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B5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0854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21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B5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22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23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24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B5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0854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25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26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27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933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28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0854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29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0854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30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 </a:t>
                      </a:r>
                      <a:endParaRPr lang="ko-KR" sz="9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700" b="1" kern="100" dirty="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9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9245" marR="592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539552" y="274598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/>
              <a:t>Fig. 3</a:t>
            </a:r>
            <a:endParaRPr lang="ko-KR" altLang="en-US" sz="12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5220072" y="266162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/>
              <a:t>Fig. 6</a:t>
            </a:r>
            <a:endParaRPr lang="ko-KR" altLang="en-US" sz="1200" b="1" dirty="0"/>
          </a:p>
        </p:txBody>
      </p:sp>
      <p:graphicFrame>
        <p:nvGraphicFramePr>
          <p:cNvPr id="12" name="표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0441292"/>
              </p:ext>
            </p:extLst>
          </p:nvPr>
        </p:nvGraphicFramePr>
        <p:xfrm>
          <a:off x="1259632" y="4293096"/>
          <a:ext cx="1866900" cy="1507236"/>
        </p:xfrm>
        <a:graphic>
          <a:graphicData uri="http://schemas.openxmlformats.org/drawingml/2006/table">
            <a:tbl>
              <a:tblPr firstRow="1" firstCol="1" bandRow="1"/>
              <a:tblGrid>
                <a:gridCol w="338744"/>
                <a:gridCol w="1528156"/>
              </a:tblGrid>
              <a:tr h="116840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No expression 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840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Patchy weak expression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Patchy moderate expression</a:t>
                      </a:r>
                      <a:endParaRPr lang="ko-KR" sz="10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840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5B5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Patchy strong expression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840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Diffuse weak expression</a:t>
                      </a:r>
                      <a:endParaRPr lang="ko-KR" sz="10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840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Diffuse moderate expression 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30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Diffuse strong expression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30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Episomal HPV DNA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30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Integrated HPV DNA</a:t>
                      </a:r>
                      <a:endParaRPr lang="ko-KR" sz="10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graphicFrame>
        <p:nvGraphicFramePr>
          <p:cNvPr id="18" name="표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7202987"/>
              </p:ext>
            </p:extLst>
          </p:nvPr>
        </p:nvGraphicFramePr>
        <p:xfrm>
          <a:off x="5940152" y="5013176"/>
          <a:ext cx="1866900" cy="1507236"/>
        </p:xfrm>
        <a:graphic>
          <a:graphicData uri="http://schemas.openxmlformats.org/drawingml/2006/table">
            <a:tbl>
              <a:tblPr firstRow="1" firstCol="1" bandRow="1"/>
              <a:tblGrid>
                <a:gridCol w="338744"/>
                <a:gridCol w="1528156"/>
              </a:tblGrid>
              <a:tr h="116840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No expression 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840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D7D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Patchy weak expression</a:t>
                      </a:r>
                      <a:endParaRPr lang="ko-KR" sz="10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5A3AD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Patchy moderate expression</a:t>
                      </a:r>
                      <a:endParaRPr lang="ko-KR" sz="10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840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5B5B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Patchy strong expression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840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Diffuse weak expression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840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DB3E2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Diffuse moderate expression </a:t>
                      </a:r>
                      <a:endParaRPr lang="ko-KR" sz="10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30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 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Diffuse strong expression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30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***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Episomal HPV DNA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30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>
                          <a:effectLst/>
                          <a:latin typeface="Times New Roman"/>
                          <a:ea typeface="맑은 고딕"/>
                          <a:cs typeface="Times New Roman"/>
                        </a:rPr>
                        <a:t>…</a:t>
                      </a:r>
                      <a:endParaRPr lang="ko-KR" sz="1000" kern="10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effectLst/>
                          <a:latin typeface="맑은 고딕"/>
                          <a:ea typeface="맑은 고딕"/>
                          <a:cs typeface="Times New Roman"/>
                        </a:rPr>
                        <a:t>Integrated HPV DNA</a:t>
                      </a:r>
                      <a:endParaRPr lang="ko-KR" sz="1000" kern="100" dirty="0">
                        <a:effectLst/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73271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전산실TEST\Desktop\cervix cancer ck7ck19\사진 및 FIGURE\사진\CK7CK19정리\SCC\07-4264\HE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0488" y="2215642"/>
            <a:ext cx="2814424" cy="21108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전산실TEST\Desktop\cervix cancer ck7ck19\사진 및 FIGURE\사진\CK7CK19정리\SCC\07-4264\CK7-2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6521" y="1132391"/>
            <a:ext cx="2814424" cy="21108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전산실TEST\Desktop\cervix cancer ck7ck19\사진 및 FIGURE\사진\CK7CK19정리\SCC\07-4264\CK19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10408" y="1132391"/>
            <a:ext cx="2814425" cy="21108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전산실TEST\Desktop\cervix cancer ck7ck19\사진 및 FIGURE\사진\CK7CK19정리\SCC\07-4264\P16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1097" y="3318076"/>
            <a:ext cx="2814426" cy="21108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C:\Users\전산실TEST\Desktop\cervix cancer ck7ck19\사진 및 FIGURE\사진\CK7CK19정리\SCC\07-4264\HPV-1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10408" y="3318076"/>
            <a:ext cx="2814425" cy="21108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88044" y="856184"/>
            <a:ext cx="22237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/>
              <a:t>Supplemental Fig. 1</a:t>
            </a:r>
            <a:endParaRPr lang="ko-KR" altLang="en-US" sz="1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128152" y="3957128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a</a:t>
            </a:r>
            <a:endParaRPr lang="ko-KR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026519" y="2873877"/>
            <a:ext cx="322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b</a:t>
            </a:r>
            <a:endParaRPr lang="ko-KR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5910408" y="2873877"/>
            <a:ext cx="2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c</a:t>
            </a:r>
            <a:endParaRPr lang="ko-KR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3031097" y="505956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d</a:t>
            </a:r>
            <a:endParaRPr lang="ko-KR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5894876" y="507388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e</a:t>
            </a:r>
            <a:endParaRPr lang="ko-KR" altLang="en-US" dirty="0"/>
          </a:p>
        </p:txBody>
      </p:sp>
      <p:sp>
        <p:nvSpPr>
          <p:cNvPr id="3" name="직사각형 2"/>
          <p:cNvSpPr/>
          <p:nvPr/>
        </p:nvSpPr>
        <p:spPr>
          <a:xfrm>
            <a:off x="150284" y="5589240"/>
            <a:ext cx="874219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 smtClean="0"/>
              <a:t>Supplemental Fig. 1 </a:t>
            </a:r>
            <a:r>
              <a:rPr lang="en-US" altLang="ko-KR" sz="1200" dirty="0" smtClean="0"/>
              <a:t>Low </a:t>
            </a:r>
            <a:r>
              <a:rPr lang="en-US" altLang="ko-KR" sz="1200" dirty="0" smtClean="0"/>
              <a:t>power view (x40) of HE staining (a) and CK7 (b), CK19 (c), p16 (d), and HR HPV (e) expression pattern of SCC#19. 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40994886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5</TotalTime>
  <Words>260</Words>
  <Application>Microsoft Office PowerPoint</Application>
  <PresentationFormat>화면 슬라이드 쇼(4:3)</PresentationFormat>
  <Paragraphs>387</Paragraphs>
  <Slides>2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3" baseType="lpstr"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전산실TEST</dc:creator>
  <cp:lastModifiedBy>전산실TEST</cp:lastModifiedBy>
  <cp:revision>18</cp:revision>
  <dcterms:created xsi:type="dcterms:W3CDTF">2017-02-12T23:30:26Z</dcterms:created>
  <dcterms:modified xsi:type="dcterms:W3CDTF">2017-02-13T06:48:27Z</dcterms:modified>
</cp:coreProperties>
</file>